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2C78B-6F51-4824-A933-A88C57A3E5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2CBB6-9387-43F2-A58D-9FB213249B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A26528-2D02-4318-BA9D-CADB44E5BD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C8CBB8-47EA-4963-9E0E-69611B690E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33AE5C-379D-4ED2-AF3A-B9161AB483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2654B-8918-4A9E-AC1E-4C5103978A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8C0A3-8F52-4E9C-AB64-7E39A2ED6D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9BF001-CDD0-4A5F-9250-C3A5B995FC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E1D12-9C66-4943-BF30-DD58B8D136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07E69-8785-4282-8035-917F275F6B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86B381-9820-41F7-9495-7D7E4B14E8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6647D-6CB9-426E-A2E1-BEFEE3BF46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78D3E5-F0DB-46B7-A1FC-05E53D57C94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wmf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wmf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1.wmf"/><Relationship Id="rId2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kstvak 110"/>
          <p:cNvSpPr/>
          <p:nvPr/>
        </p:nvSpPr>
        <p:spPr>
          <a:xfrm>
            <a:off x="7616880" y="0"/>
            <a:ext cx="145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Additional Figur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5"/>
          <p:cNvGraphicFramePr/>
          <p:nvPr/>
        </p:nvGraphicFramePr>
        <p:xfrm>
          <a:off x="311040" y="380880"/>
          <a:ext cx="1787760" cy="15066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11040" y="380880"/>
                    <a:ext cx="178776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Text Box 6"/>
          <p:cNvSpPr/>
          <p:nvPr/>
        </p:nvSpPr>
        <p:spPr>
          <a:xfrm rot="16200000">
            <a:off x="-115560" y="1053000"/>
            <a:ext cx="66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%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Object 7"/>
          <p:cNvGraphicFramePr/>
          <p:nvPr/>
        </p:nvGraphicFramePr>
        <p:xfrm>
          <a:off x="5562720" y="380880"/>
          <a:ext cx="1788840" cy="15066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6" name="Object 7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562720" y="380880"/>
                    <a:ext cx="178884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Object 8"/>
          <p:cNvGraphicFramePr/>
          <p:nvPr/>
        </p:nvGraphicFramePr>
        <p:xfrm>
          <a:off x="2057400" y="380880"/>
          <a:ext cx="1787400" cy="15066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8" name="Object 8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057400" y="380880"/>
                    <a:ext cx="178740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Object 9"/>
          <p:cNvGraphicFramePr/>
          <p:nvPr/>
        </p:nvGraphicFramePr>
        <p:xfrm>
          <a:off x="3808440" y="380880"/>
          <a:ext cx="1789200" cy="15066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0" name="Object 9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808440" y="380880"/>
                    <a:ext cx="178920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Object 10"/>
          <p:cNvGraphicFramePr/>
          <p:nvPr/>
        </p:nvGraphicFramePr>
        <p:xfrm>
          <a:off x="7299360" y="380880"/>
          <a:ext cx="1768320" cy="150660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2" name="Object 10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7299360" y="380880"/>
                    <a:ext cx="176832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3" name="Text Box 70"/>
          <p:cNvSpPr/>
          <p:nvPr/>
        </p:nvSpPr>
        <p:spPr>
          <a:xfrm>
            <a:off x="457200" y="228600"/>
            <a:ext cx="689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D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70"/>
          <p:cNvSpPr/>
          <p:nvPr/>
        </p:nvSpPr>
        <p:spPr>
          <a:xfrm>
            <a:off x="2206800" y="228600"/>
            <a:ext cx="68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DC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70"/>
          <p:cNvSpPr/>
          <p:nvPr/>
        </p:nvSpPr>
        <p:spPr>
          <a:xfrm>
            <a:off x="3959280" y="228600"/>
            <a:ext cx="689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DC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70"/>
          <p:cNvSpPr/>
          <p:nvPr/>
        </p:nvSpPr>
        <p:spPr>
          <a:xfrm>
            <a:off x="5711760" y="228600"/>
            <a:ext cx="689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D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70"/>
          <p:cNvSpPr/>
          <p:nvPr/>
        </p:nvSpPr>
        <p:spPr>
          <a:xfrm>
            <a:off x="7388280" y="228600"/>
            <a:ext cx="1069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onocy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6"/>
          <p:cNvSpPr/>
          <p:nvPr/>
        </p:nvSpPr>
        <p:spPr>
          <a:xfrm rot="16200000">
            <a:off x="-349560" y="2637360"/>
            <a:ext cx="113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d. FI CD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9" name="Object 17"/>
          <p:cNvGraphicFramePr/>
          <p:nvPr/>
        </p:nvGraphicFramePr>
        <p:xfrm>
          <a:off x="314280" y="1998720"/>
          <a:ext cx="1768680" cy="150660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60" name="Object 17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14280" y="1998720"/>
                    <a:ext cx="176868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1" name="Object 18"/>
          <p:cNvGraphicFramePr/>
          <p:nvPr/>
        </p:nvGraphicFramePr>
        <p:xfrm>
          <a:off x="5565600" y="1998720"/>
          <a:ext cx="1770120" cy="150660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62" name="Object 18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5565600" y="1998720"/>
                    <a:ext cx="177012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3" name="Object 19"/>
          <p:cNvGraphicFramePr/>
          <p:nvPr/>
        </p:nvGraphicFramePr>
        <p:xfrm>
          <a:off x="2041560" y="1998720"/>
          <a:ext cx="1808280" cy="150660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64" name="Object 19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2041560" y="1998720"/>
                    <a:ext cx="180828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5" name="Object 20"/>
          <p:cNvGraphicFramePr/>
          <p:nvPr/>
        </p:nvGraphicFramePr>
        <p:xfrm>
          <a:off x="3811680" y="1998720"/>
          <a:ext cx="1770120" cy="150660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66" name="Object 20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3811680" y="1998720"/>
                    <a:ext cx="177012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7" name="Object 21"/>
          <p:cNvGraphicFramePr/>
          <p:nvPr/>
        </p:nvGraphicFramePr>
        <p:xfrm>
          <a:off x="7273800" y="1998720"/>
          <a:ext cx="1808280" cy="150660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68" name="Object 21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7273800" y="1998720"/>
                    <a:ext cx="180828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9" name="Text Box 22"/>
          <p:cNvSpPr/>
          <p:nvPr/>
        </p:nvSpPr>
        <p:spPr>
          <a:xfrm>
            <a:off x="629640" y="3429000"/>
            <a:ext cx="538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P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0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23"/>
          <p:cNvSpPr/>
          <p:nvPr/>
        </p:nvSpPr>
        <p:spPr>
          <a:xfrm>
            <a:off x="1338120" y="3429000"/>
            <a:ext cx="587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on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24"/>
          <p:cNvSpPr/>
          <p:nvPr/>
        </p:nvSpPr>
        <p:spPr>
          <a:xfrm>
            <a:off x="2364840" y="3429000"/>
            <a:ext cx="538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P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0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5"/>
          <p:cNvSpPr/>
          <p:nvPr/>
        </p:nvSpPr>
        <p:spPr>
          <a:xfrm>
            <a:off x="3073320" y="3429000"/>
            <a:ext cx="587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on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26"/>
          <p:cNvSpPr/>
          <p:nvPr/>
        </p:nvSpPr>
        <p:spPr>
          <a:xfrm>
            <a:off x="4112640" y="3429000"/>
            <a:ext cx="538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P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0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7"/>
          <p:cNvSpPr/>
          <p:nvPr/>
        </p:nvSpPr>
        <p:spPr>
          <a:xfrm>
            <a:off x="4821120" y="3429000"/>
            <a:ext cx="587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on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8"/>
          <p:cNvSpPr/>
          <p:nvPr/>
        </p:nvSpPr>
        <p:spPr>
          <a:xfrm>
            <a:off x="5865480" y="3429000"/>
            <a:ext cx="538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P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0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9"/>
          <p:cNvSpPr/>
          <p:nvPr/>
        </p:nvSpPr>
        <p:spPr>
          <a:xfrm>
            <a:off x="6573600" y="3429000"/>
            <a:ext cx="587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on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30"/>
          <p:cNvSpPr/>
          <p:nvPr/>
        </p:nvSpPr>
        <p:spPr>
          <a:xfrm>
            <a:off x="7617960" y="3429000"/>
            <a:ext cx="538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P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0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31"/>
          <p:cNvSpPr/>
          <p:nvPr/>
        </p:nvSpPr>
        <p:spPr>
          <a:xfrm>
            <a:off x="8326440" y="3429000"/>
            <a:ext cx="587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on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kstvak 31"/>
          <p:cNvSpPr/>
          <p:nvPr/>
        </p:nvSpPr>
        <p:spPr>
          <a:xfrm>
            <a:off x="1800" y="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kstvak 32"/>
          <p:cNvSpPr/>
          <p:nvPr/>
        </p:nvSpPr>
        <p:spPr>
          <a:xfrm>
            <a:off x="0" y="4114800"/>
            <a:ext cx="31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1" name="Object 12"/>
          <p:cNvGraphicFramePr/>
          <p:nvPr/>
        </p:nvGraphicFramePr>
        <p:xfrm>
          <a:off x="295200" y="4573440"/>
          <a:ext cx="1787760" cy="150660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82" name="Object 12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295200" y="4573440"/>
                    <a:ext cx="1787760" cy="150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3" name="Text Box 22"/>
          <p:cNvSpPr/>
          <p:nvPr/>
        </p:nvSpPr>
        <p:spPr>
          <a:xfrm>
            <a:off x="620280" y="6004080"/>
            <a:ext cx="538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P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0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23"/>
          <p:cNvSpPr/>
          <p:nvPr/>
        </p:nvSpPr>
        <p:spPr>
          <a:xfrm>
            <a:off x="1328760" y="6004080"/>
            <a:ext cx="587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on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70"/>
          <p:cNvSpPr/>
          <p:nvPr/>
        </p:nvSpPr>
        <p:spPr>
          <a:xfrm>
            <a:off x="457200" y="429588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MDS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kstvak 31"/>
          <p:cNvSpPr/>
          <p:nvPr/>
        </p:nvSpPr>
        <p:spPr>
          <a:xfrm>
            <a:off x="1800" y="18288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6"/>
          <p:cNvSpPr/>
          <p:nvPr/>
        </p:nvSpPr>
        <p:spPr>
          <a:xfrm rot="16200000">
            <a:off x="-117000" y="5223600"/>
            <a:ext cx="66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%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43"/>
          <p:cNvSpPr/>
          <p:nvPr/>
        </p:nvSpPr>
        <p:spPr>
          <a:xfrm>
            <a:off x="4038480" y="4232160"/>
            <a:ext cx="5105520" cy="246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Additional Figure 3. PBDC frequencies and activation status and MDSC frequencies in mCRPC patients and healthy individuals. 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Frequencies of cDC, pDC, monocytes and gMDSC and mMDSC subsets, and activation status of cDC, pDC and monocytes was determined in mCRPC patients before prostate GVAX/ipilimumab therapy and age- and sex-matched healthy donors (HD). Percentage </a:t>
            </a: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A)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and activation status </a:t>
            </a: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B)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of cDC1, cDC2, cDC3, pDC and monocytes and percentage of </a:t>
            </a: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)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mMDSC are shown. Differences in percentage or activation between mCRPC and HD were analyzed with the two-sample Mann-Whitney U test. Differences were considered significant when p&lt;0.05, as indicated with the given p-value.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20T11:45:14Z</dcterms:created>
  <dc:creator>s.santegoets</dc:creator>
  <dc:description/>
  <dc:language>en-US</dc:language>
  <cp:lastModifiedBy>Phil en Sas</cp:lastModifiedBy>
  <dcterms:modified xsi:type="dcterms:W3CDTF">2014-07-29T20:14:57Z</dcterms:modified>
  <cp:revision>341</cp:revision>
  <dc:subject/>
  <dc:title>Slide 1</dc:title>
</cp:coreProperties>
</file>